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315DC7-CBB2-4ABE-8B2D-E5F58C5C82D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43E555-34D8-4B66-8867-C021F7958C9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F573CF-9087-4EBC-ACD7-A06E68F35CA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9544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62320" y="182520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2856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9544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62320" y="4098240"/>
            <a:ext cx="253944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21C6BC-56D4-4293-9453-BF44442E523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86C8D-71F8-41A2-9D6B-A4F0B91FEF7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7EDCCE-C6CA-439F-B781-A0921F4BD9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33A23-3EFB-412E-97EF-73B19F767B3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2A2C3B-2A95-4FE9-B7C8-084B124AEF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28560" y="365040"/>
            <a:ext cx="788688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FB764C-2245-4AC3-916A-3A27F997D9C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C6895C-C372-4E5F-82C6-2A673C67EA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0280" y="409824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C15A0-B767-4134-AA71-E1A9681975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2856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0280" y="1825200"/>
            <a:ext cx="384876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28560" y="4098240"/>
            <a:ext cx="7886880" cy="20754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5E3BA7-2A26-4E44-9B2E-6DDDE7ADD8D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28560" y="365040"/>
            <a:ext cx="7886880" cy="132552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28560" y="1825200"/>
            <a:ext cx="7886880" cy="435132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2820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46DCE45-A84F-4B14-AC00-6CD3DB95CA81}" type="datetime">
              <a:rPr b="0" lang="zh-CN" sz="1200" spc="-1" strike="noStrike">
                <a:solidFill>
                  <a:srgbClr val="898989"/>
                </a:solidFill>
                <a:latin typeface="Calibri"/>
              </a:rPr>
              <a:t>26/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029040" y="6356520"/>
            <a:ext cx="308592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457680" y="6356520"/>
            <a:ext cx="2057400" cy="36504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4EB9DFE-70CD-468E-801F-68A8F4F4221F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直线连接符 1"/>
          <p:cNvSpPr/>
          <p:nvPr/>
        </p:nvSpPr>
        <p:spPr>
          <a:xfrm>
            <a:off x="1495440" y="239544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直线连接符 23"/>
          <p:cNvSpPr/>
          <p:nvPr/>
        </p:nvSpPr>
        <p:spPr>
          <a:xfrm>
            <a:off x="1479600" y="450684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直线连接符 24"/>
          <p:cNvSpPr/>
          <p:nvPr/>
        </p:nvSpPr>
        <p:spPr>
          <a:xfrm>
            <a:off x="1495440" y="1998720"/>
            <a:ext cx="53640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文本框 65"/>
          <p:cNvSpPr/>
          <p:nvPr/>
        </p:nvSpPr>
        <p:spPr>
          <a:xfrm>
            <a:off x="-171360" y="1558800"/>
            <a:ext cx="90169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300" spc="-1" strike="noStrike">
                <a:solidFill>
                  <a:srgbClr val="000000"/>
                </a:solidFill>
                <a:latin typeface="Calibri"/>
                <a:ea typeface="微软雅黑"/>
              </a:rPr>
              <a:t>SUPPLEMENTARY TABLE 6</a:t>
            </a: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  Thermal Cycling Conditions (Wild-type Fragment Amplification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文本框 57"/>
          <p:cNvSpPr/>
          <p:nvPr/>
        </p:nvSpPr>
        <p:spPr>
          <a:xfrm>
            <a:off x="1600200" y="4175280"/>
            <a:ext cx="720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Hold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文本框 60"/>
          <p:cNvSpPr/>
          <p:nvPr/>
        </p:nvSpPr>
        <p:spPr>
          <a:xfrm>
            <a:off x="3776760" y="243216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94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文本框 61"/>
          <p:cNvSpPr/>
          <p:nvPr/>
        </p:nvSpPr>
        <p:spPr>
          <a:xfrm>
            <a:off x="1600200" y="2430360"/>
            <a:ext cx="17542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Initial denatu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本框 62"/>
          <p:cNvSpPr/>
          <p:nvPr/>
        </p:nvSpPr>
        <p:spPr>
          <a:xfrm>
            <a:off x="4722840" y="2443320"/>
            <a:ext cx="1204920" cy="30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04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2 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本框 69"/>
          <p:cNvSpPr/>
          <p:nvPr/>
        </p:nvSpPr>
        <p:spPr>
          <a:xfrm>
            <a:off x="1600200" y="3301920"/>
            <a:ext cx="1217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Annealing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本框 73"/>
          <p:cNvSpPr/>
          <p:nvPr/>
        </p:nvSpPr>
        <p:spPr>
          <a:xfrm>
            <a:off x="4722840" y="3271680"/>
            <a:ext cx="1204920" cy="3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30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本框 4"/>
          <p:cNvSpPr/>
          <p:nvPr/>
        </p:nvSpPr>
        <p:spPr>
          <a:xfrm>
            <a:off x="3776760" y="288432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98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本框 8"/>
          <p:cNvSpPr/>
          <p:nvPr/>
        </p:nvSpPr>
        <p:spPr>
          <a:xfrm>
            <a:off x="3776760" y="378936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68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本框 9"/>
          <p:cNvSpPr/>
          <p:nvPr/>
        </p:nvSpPr>
        <p:spPr>
          <a:xfrm>
            <a:off x="3776760" y="3336840"/>
            <a:ext cx="718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62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本框 11"/>
          <p:cNvSpPr/>
          <p:nvPr/>
        </p:nvSpPr>
        <p:spPr>
          <a:xfrm>
            <a:off x="3808440" y="4148280"/>
            <a:ext cx="7207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4°C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本框 15"/>
          <p:cNvSpPr/>
          <p:nvPr/>
        </p:nvSpPr>
        <p:spPr>
          <a:xfrm>
            <a:off x="4722840" y="3733920"/>
            <a:ext cx="1204920" cy="358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2 mi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文本框 19"/>
          <p:cNvSpPr/>
          <p:nvPr/>
        </p:nvSpPr>
        <p:spPr>
          <a:xfrm>
            <a:off x="4722840" y="2858040"/>
            <a:ext cx="1204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10s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文本框 29"/>
          <p:cNvSpPr/>
          <p:nvPr/>
        </p:nvSpPr>
        <p:spPr>
          <a:xfrm>
            <a:off x="4722840" y="4195800"/>
            <a:ext cx="1204920" cy="306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54000" bIns="54000" anchor="ctr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300" spc="-1" strike="noStrike">
                <a:solidFill>
                  <a:srgbClr val="000000"/>
                </a:solidFill>
                <a:latin typeface="Times New Roman"/>
              </a:rPr>
              <a:t>∞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文本框 32"/>
          <p:cNvSpPr/>
          <p:nvPr/>
        </p:nvSpPr>
        <p:spPr>
          <a:xfrm>
            <a:off x="5289480" y="4151160"/>
            <a:ext cx="2441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本框 33"/>
          <p:cNvSpPr/>
          <p:nvPr/>
        </p:nvSpPr>
        <p:spPr>
          <a:xfrm>
            <a:off x="5365800" y="241920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1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文本框 34"/>
          <p:cNvSpPr/>
          <p:nvPr/>
        </p:nvSpPr>
        <p:spPr>
          <a:xfrm>
            <a:off x="1865160" y="2058840"/>
            <a:ext cx="8240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Step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文本框 37"/>
          <p:cNvSpPr/>
          <p:nvPr/>
        </p:nvSpPr>
        <p:spPr>
          <a:xfrm>
            <a:off x="5035680" y="2085840"/>
            <a:ext cx="12016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Tim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文本框 38"/>
          <p:cNvSpPr/>
          <p:nvPr/>
        </p:nvSpPr>
        <p:spPr>
          <a:xfrm>
            <a:off x="6197760" y="2066760"/>
            <a:ext cx="64584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Cycl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本框 10"/>
          <p:cNvSpPr/>
          <p:nvPr/>
        </p:nvSpPr>
        <p:spPr>
          <a:xfrm>
            <a:off x="3483000" y="2054160"/>
            <a:ext cx="1136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Temperature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文本框 5"/>
          <p:cNvSpPr/>
          <p:nvPr/>
        </p:nvSpPr>
        <p:spPr>
          <a:xfrm>
            <a:off x="1600200" y="2867040"/>
            <a:ext cx="12175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Denaturat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文本框 6"/>
          <p:cNvSpPr/>
          <p:nvPr/>
        </p:nvSpPr>
        <p:spPr>
          <a:xfrm>
            <a:off x="1600200" y="3736800"/>
            <a:ext cx="9874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imes New Roman"/>
                <a:ea typeface="微软雅黑"/>
              </a:rPr>
              <a:t>Extension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文本框 20"/>
          <p:cNvSpPr/>
          <p:nvPr/>
        </p:nvSpPr>
        <p:spPr>
          <a:xfrm>
            <a:off x="5346720" y="3313080"/>
            <a:ext cx="2327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35X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右大括号 40"/>
          <p:cNvSpPr/>
          <p:nvPr/>
        </p:nvSpPr>
        <p:spPr>
          <a:xfrm>
            <a:off x="5754600" y="2978280"/>
            <a:ext cx="324000" cy="1008000"/>
          </a:xfrm>
          <a:custGeom>
            <a:avLst/>
            <a:gdLst>
              <a:gd name="textAreaLeft" fmla="*/ 0 w 324000"/>
              <a:gd name="textAreaRight" fmla="*/ 117000 w 324000"/>
              <a:gd name="textAreaTop" fmla="*/ 8280 h 1008000"/>
              <a:gd name="textAreaBottom" fmla="*/ 999720 h 10080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289"/>
                  <a:pt x="10800" y="578"/>
                </a:cubicBezTo>
                <a:lnTo>
                  <a:pt x="10800" y="10222"/>
                </a:lnTo>
                <a:cubicBezTo>
                  <a:pt x="10800" y="10511"/>
                  <a:pt x="16200" y="10800"/>
                  <a:pt x="21600" y="10800"/>
                </a:cubicBezTo>
                <a:cubicBezTo>
                  <a:pt x="16200" y="10800"/>
                  <a:pt x="10800" y="11089"/>
                  <a:pt x="10800" y="11378"/>
                </a:cubicBezTo>
                <a:lnTo>
                  <a:pt x="10800" y="21022"/>
                </a:lnTo>
                <a:cubicBezTo>
                  <a:pt x="10800" y="21311"/>
                  <a:pt x="5400" y="21600"/>
                  <a:pt x="0" y="21600"/>
                </a:cubicBezTo>
              </a:path>
            </a:pathLst>
          </a:custGeom>
          <a:noFill/>
          <a:ln w="12600">
            <a:solidFill>
              <a:srgbClr val="0d0d0d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09T12:44:00Z</dcterms:created>
  <dc:creator>ghl</dc:creator>
  <dc:description/>
  <dc:language>en-US</dc:language>
  <cp:lastModifiedBy>墨铁</cp:lastModifiedBy>
  <dcterms:modified xsi:type="dcterms:W3CDTF">2026-05-25T09:45:20Z</dcterms:modified>
  <cp:revision>57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4EF8A1A72F364BE3A5218373BDAA2C6E_13</vt:lpwstr>
  </property>
  <property fmtid="{D5CDD505-2E9C-101B-9397-08002B2CF9AE}" pid="3" name="KSOProductBuildVer">
    <vt:lpwstr>2052-12.1.0.26375</vt:lpwstr>
  </property>
</Properties>
</file>